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9" r:id="rId2"/>
    <p:sldId id="260" r:id="rId3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22"/>
    <p:restoredTop sz="83946"/>
  </p:normalViewPr>
  <p:slideViewPr>
    <p:cSldViewPr snapToGrid="0">
      <p:cViewPr varScale="1">
        <p:scale>
          <a:sx n="89" d="100"/>
          <a:sy n="89" d="100"/>
        </p:scale>
        <p:origin x="335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197FFD-F7D0-6B44-8E50-F054F3374A90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8850" y="1143000"/>
            <a:ext cx="2400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3D2CB-36E4-CC4C-8389-D626B50AD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605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E3D2CB-36E4-CC4C-8389-D626B50AD18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405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619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244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030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450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065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424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519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591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865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333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27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53765-EFB3-FF44-9811-680A4EB4DF78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359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3" Type="http://schemas.openxmlformats.org/officeDocument/2006/relationships/image" Target="../media/image1.emf"/><Relationship Id="rId21" Type="http://schemas.openxmlformats.org/officeDocument/2006/relationships/image" Target="../media/image19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252266C-ED87-D3C2-514C-66DDE78127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2714" y="0"/>
            <a:ext cx="1219687" cy="199035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AB946AB-78E9-944C-E87E-AABEA21323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71416" y="0"/>
            <a:ext cx="1219687" cy="199035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3EEAA59-F6FF-EC98-94E5-5C977DF6F2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8998" y="3967205"/>
            <a:ext cx="1219688" cy="199035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D145B92-AAD5-944A-D59C-A1637A4D8B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71416" y="3967205"/>
            <a:ext cx="1219688" cy="199035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85C8D95-C401-A823-E6FE-5C2941848D4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76" y="5981216"/>
            <a:ext cx="1219688" cy="199035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97483D9-C8CA-A334-BF27-7D08EE931D5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48998" y="5981216"/>
            <a:ext cx="1219688" cy="199035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DDB0A66-BD9A-99F2-D834-97AA2437C70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83511" y="5981216"/>
            <a:ext cx="1229337" cy="199035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12314A7-AAB6-059B-5FEC-20E6A78E956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82714" y="1938319"/>
            <a:ext cx="1229337" cy="199035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027EFCA-D492-B1E3-1506-DE9FC7299C1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748998" y="1938319"/>
            <a:ext cx="1229337" cy="1990355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F1B6D35-8D5B-C912-7F1B-DEEE4FE90B6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282714" y="3967205"/>
            <a:ext cx="1229337" cy="1990355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84B33261-27C4-EFF9-0038-B375C601483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483511" y="3967205"/>
            <a:ext cx="1229337" cy="1990355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5EF65F75-F45A-1ECB-7178-536CC0F208F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6576" y="3967205"/>
            <a:ext cx="1229337" cy="1990355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386FCDA-E2F1-506E-ECFE-15E2A8F7418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971416" y="1938319"/>
            <a:ext cx="1229337" cy="199035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F21336B2-0D5A-4774-586B-BF5F5F427C7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6576" y="1938319"/>
            <a:ext cx="1234142" cy="1998134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DACEF198-B190-7039-B90F-C7D5DE10FA4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6576" y="0"/>
            <a:ext cx="1219531" cy="1974478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581F9A4B-FFA2-840D-C39D-46EBD706F13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748998" y="0"/>
            <a:ext cx="1219687" cy="1974731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1433602-EA51-8CAF-38B9-7F088EC2397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282714" y="5981216"/>
            <a:ext cx="1229337" cy="199035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A4B18F6-75B6-DD16-E89C-C4B6641E7C9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483511" y="0"/>
            <a:ext cx="1232963" cy="199035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9C2AB97-32C6-78C8-EC3E-287B3CAAEA3B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483511" y="1938319"/>
            <a:ext cx="1219686" cy="19747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7576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5ED3-77AE-1839-AFD8-D141D40494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just"/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9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ite-matched OA Medial vs CAD Medial Candidate m/z Comparisons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7 of 44 candidates significantly elevated in OA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cross the patient cohort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y one-sided t-test. (p&lt;0.05) 10 additional markers trending towards significance (0.1 &lt; p &lt; 0.05).</a:t>
            </a:r>
            <a:b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92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3</TotalTime>
  <Words>52</Words>
  <Application>Microsoft Macintosh PowerPoint</Application>
  <PresentationFormat>Custom</PresentationFormat>
  <Paragraphs>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Supplemental Figure 9: Site-matched OA Medial vs CAD Medial Candidate m/z Comparisons. 7 of 44 candidates significantly elevated in OA across the patient cohort by one-sided t-test. (p&lt;0.05) 10 additional markers trending towards significance (0.1 &lt; p &lt; 0.05)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 Schurman</dc:creator>
  <cp:lastModifiedBy>Charlie Schurman</cp:lastModifiedBy>
  <cp:revision>19</cp:revision>
  <dcterms:created xsi:type="dcterms:W3CDTF">2024-02-20T19:43:53Z</dcterms:created>
  <dcterms:modified xsi:type="dcterms:W3CDTF">2024-06-18T18:56:39Z</dcterms:modified>
</cp:coreProperties>
</file>